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8" d="100"/>
          <a:sy n="138" d="100"/>
        </p:scale>
        <p:origin x="12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315C42-5E6E-426F-B79A-91029C8128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EB81E04-74D6-468D-BCE6-7DBF2FE043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E41FCE-BD85-46BD-98C1-47C7F5388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EAE03B-F306-412A-9ECF-EFBD67D25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BD126B-2944-41A4-9075-14EDC7FD0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338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C82CF2-9657-4FFB-B6C6-CCA9B45A4A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897B26-014B-4D0B-9722-F5E30FD4DC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FE6C05-03A1-4B96-92EB-ED79EACBA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423948-CFFB-450F-A763-25B3FD872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F058C4-3B05-415D-BC6B-0A68D038C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9380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5AA6325-9EB5-4CA6-B4FA-D0B2B4AE0D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D018863-C32A-4B07-8DBA-AF61DF77D7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A5AD61-1399-4EAC-ACEA-AD40408F6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5BE4209-C304-471C-91DC-90DCC7515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B801D3-9F1E-45A7-A6B0-1AB4B6274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7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87EABA-2D7E-44F8-9631-6535B8A91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E0D0C4C-A0B6-466B-92B3-2CABE02368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425103-D225-4B34-8569-A0FC86794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9392B4-0CA3-4C83-BDD5-B36024715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96F92E-FAAF-4FE8-95F9-F8A847C05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059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B1D4FF-6C0B-4697-8AA0-273A45555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C3D4E00-D250-49F0-8FEA-17A6E311C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0D2A0F-7B97-4235-B92D-AE24C8F3B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15991D-3C3A-4C45-87E3-F531C65065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8144AD-61A3-4BBD-A3FC-E209EA85F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49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D5F234-B20C-4097-B0CF-2A5B2ECF42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652574B-B11C-4676-955E-7E3366F2DD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7A8A7F-528C-44F8-B5CD-A731E821D8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C12853-9DB0-4047-9007-F1BA15D40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3A01AD-BD39-4886-BB32-5C2E2287C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CA5D51-ADD9-41DD-ACD3-6177E67B8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136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10A814-66D2-4368-8D23-B40B4B647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D05BD2-5C70-47DE-A598-7E69F7ECF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DFD81CF-7010-4F59-9B39-FC4FC944F6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BCFCC17-3EEC-433B-9A97-F81CD42D3C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2B0F1DE-E92D-40D2-9D11-A148FCD5C9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F4E3F3-B92B-4C10-9FC6-940B2FEDF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73D052C-016C-4550-BEE0-30F7BD3D8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A7D1F0D-5C94-4DE7-9002-8D794F91D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6986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CBEA6B-6168-4014-93AA-98DE7A73F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E104363-69C0-4878-B3C8-9DEC44273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B36AE2-D08D-4740-AFC0-0D00759CE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AF11D4E-3B7B-4556-B4E8-716C2E60B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35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4F22957-C426-404E-90C9-AAF376D6E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9A16FE1-7CDE-4F82-A4EA-26D067B77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61431BE-4B17-4D04-BB3D-7FE1FE25C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292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279C51-E043-4A94-9F9D-A377EC120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D2B4C3-2CEB-4AE7-9AAE-2492D56986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52826B7-AB8E-47C1-B074-E7CE430E53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DB3AE8-405C-421E-83AC-703E56D56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BBA72B-4E37-4955-964C-4EB9DBD98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A9DE9A-762B-4540-A021-EAD77205E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3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79C2C2-D7B0-44E9-B4BC-1CDE6ACE2F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8B6DFA9-4CE3-45C9-ABA5-86C4B447EB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1706DE2-60C6-4960-8C87-54C31B3DE0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EAF8542-5E15-474A-9730-8EC783FEB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9DC207-FF8B-45D3-9791-37620C693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40FB60F-E816-40FF-9590-C148BBA11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158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7F91CE8-498E-46F1-896C-4E72D746F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82C6AD3-49C3-4A74-9DBA-A13F78804D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6BBB6A-9A0A-46F4-B83F-601A9E6FED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20BBD-F029-45AC-9BFF-CD3E318AB395}" type="datetimeFigureOut">
              <a:rPr lang="zh-CN" altLang="en-US" smtClean="0"/>
              <a:t>2020/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877D50-D386-43D9-8BE4-D74580B24F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95E186-74B9-48FB-A59A-9DD818E55C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F42CF-1FC9-4B69-9794-95D5019FD0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5065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BD7D9C23-69A8-41E1-A5B1-C4CCDB5A4A04}"/>
              </a:ext>
            </a:extLst>
          </p:cNvPr>
          <p:cNvGrpSpPr/>
          <p:nvPr/>
        </p:nvGrpSpPr>
        <p:grpSpPr>
          <a:xfrm>
            <a:off x="1555723" y="999272"/>
            <a:ext cx="6853291" cy="5760000"/>
            <a:chOff x="2657160" y="999272"/>
            <a:chExt cx="6853291" cy="5760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01468B6-3621-4004-9E3F-725E727701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57160" y="999272"/>
              <a:ext cx="3594286" cy="2880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10044E66-7B8E-4FD4-A32A-B60E5551E3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16165" y="999272"/>
              <a:ext cx="3594286" cy="2880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4925B2F-A297-44C9-A411-1D7EC2FCEC8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57160" y="3879272"/>
              <a:ext cx="3594286" cy="2880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73F452D5-8840-4552-B009-1217B74E481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16165" y="3879272"/>
              <a:ext cx="3594286" cy="2880000"/>
            </a:xfrm>
            <a:prstGeom prst="rect">
              <a:avLst/>
            </a:prstGeom>
          </p:spPr>
        </p:pic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5F94AEE9-311C-4AF7-A42F-B5D09EC8FB11}"/>
              </a:ext>
            </a:extLst>
          </p:cNvPr>
          <p:cNvSpPr txBox="1"/>
          <p:nvPr/>
        </p:nvSpPr>
        <p:spPr>
          <a:xfrm>
            <a:off x="242455" y="98728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6EAB3C4-4018-4826-BE97-CDC9D51E9674}"/>
              </a:ext>
            </a:extLst>
          </p:cNvPr>
          <p:cNvSpPr txBox="1"/>
          <p:nvPr/>
        </p:nvSpPr>
        <p:spPr>
          <a:xfrm>
            <a:off x="1267691" y="54900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08E900A-8539-49EE-A46B-495CBB45F003}"/>
              </a:ext>
            </a:extLst>
          </p:cNvPr>
          <p:cNvSpPr txBox="1"/>
          <p:nvPr/>
        </p:nvSpPr>
        <p:spPr>
          <a:xfrm>
            <a:off x="8000024" y="5040060"/>
            <a:ext cx="400493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1. Kaplan–Meier’s survival of local recurrence for the postoperative chemotherapy (POCT) group and postoperative chemoradiotherapy (POCRT) group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oup of single-station pN2;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-station pN2+single-station pN1;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-station pN2+multiple-station pN1;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of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-station pN2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3403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70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威 魏</dc:creator>
  <cp:lastModifiedBy>威 魏</cp:lastModifiedBy>
  <cp:revision>5</cp:revision>
  <dcterms:created xsi:type="dcterms:W3CDTF">2020-02-08T13:04:39Z</dcterms:created>
  <dcterms:modified xsi:type="dcterms:W3CDTF">2020-02-08T14:36:55Z</dcterms:modified>
</cp:coreProperties>
</file>